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8A47C-5041-46D2-8CD3-E53FF4CCCE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B33A9-69BF-4A16-8EC1-D74F75E8D2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F3133-4BE1-4995-8171-7CEBDE4F50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EEDB6-7E38-492D-AA89-88006285E2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DFC93-9B02-445F-B184-02AEB5B43E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3608A-94AF-408A-8C77-D9CE4D4E65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519AB-4BC0-4B63-95ED-D598D1CAE9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09CEA-AE26-48CB-A9F2-3F35B9D96F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A1327-24C2-4AB7-8881-FD18487434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747F1A-696D-43E4-B2ED-0FECF922EE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BCE07-D8E1-48C1-8B58-AF50B92E59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0BAD6A-DA32-474C-B53B-657F93D541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970887-BA2D-4E0F-AA2A-9FA68DA5A8B1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Dokumente und Einstellungen\Standard1\Desktop\PCNSL5\vennpic.php.png"/>
          <p:cNvPicPr/>
          <p:nvPr/>
        </p:nvPicPr>
        <p:blipFill>
          <a:blip r:embed="rId1"/>
          <a:stretch/>
        </p:blipFill>
        <p:spPr>
          <a:xfrm>
            <a:off x="3352680" y="1295280"/>
            <a:ext cx="2857680" cy="3524400"/>
          </a:xfrm>
          <a:prstGeom prst="rect">
            <a:avLst/>
          </a:prstGeom>
          <a:ln w="0">
            <a:noFill/>
          </a:ln>
        </p:spPr>
      </p:pic>
      <p:sp>
        <p:nvSpPr>
          <p:cNvPr id="42" name="Textfeld 3"/>
          <p:cNvSpPr/>
          <p:nvPr/>
        </p:nvSpPr>
        <p:spPr>
          <a:xfrm>
            <a:off x="228600" y="4840200"/>
            <a:ext cx="86868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alibri"/>
              </a:rPr>
              <a:t>Additional file 4:</a:t>
            </a: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  GeneVenn Diagramm (http://www.bioinformatics.org/gvenn/) of genes differentially methylated between 5 samples of PCNSL and 10  hematopoietic controls (control-PCNSL, red circle), between 49 cases of systemic DLBCL and 10 haematopoietic controls (control-DLBCL, yellow circle) or between 5 cases of PCNSL and 49 cases of systemic DLBCL (PCNSL-DLBCL, green circle), respectively. There is a significant overlap of genes differentially methylated in both malignancies compared to controls. A detailed list of genes is presented in Table S3.x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1T17:30:16Z</dcterms:created>
  <dc:creator>standard</dc:creator>
  <dc:description/>
  <dc:language>en-US</dc:language>
  <cp:lastModifiedBy>Nobody</cp:lastModifiedBy>
  <dcterms:modified xsi:type="dcterms:W3CDTF">2009-12-14T06:27:45Z</dcterms:modified>
  <cp:revision>92</cp:revision>
  <dc:subject/>
  <dc:title>Folie 1</dc:title>
</cp:coreProperties>
</file>